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818A6-9877-4BF1-85C1-4160D3AB7B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3F112-F4C7-4722-8EC6-3E12042E6D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31121-2B21-4CD3-A261-04609C3730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DD179-F730-418D-BF64-28FB95AF87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441E19-26F1-43AE-AD80-12AAC16655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55F8D-2B26-4E97-A079-0F60CFC24A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7C358-BBE8-4E63-9827-B06CDD0DE2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77514-BC41-44FA-A4BA-8A989EAC03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2C9FE-F318-45CC-B8F1-D8115C9386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E61F6-6CCE-4607-A76C-3C8CF1AE3C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3EACC-A8E2-4E85-88AE-715CDBF5E7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D7590-86A7-4F5A-86CC-26BD623BB2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36AFFD-3828-4735-B44E-A2497E46738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6"/>
          <p:cNvSpPr/>
          <p:nvPr/>
        </p:nvSpPr>
        <p:spPr>
          <a:xfrm>
            <a:off x="431640" y="7246800"/>
            <a:ext cx="184320" cy="21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5"/>
          <p:cNvSpPr/>
          <p:nvPr/>
        </p:nvSpPr>
        <p:spPr>
          <a:xfrm>
            <a:off x="1117440" y="3182760"/>
            <a:ext cx="73836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+++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6"/>
          <p:cNvSpPr/>
          <p:nvPr/>
        </p:nvSpPr>
        <p:spPr>
          <a:xfrm>
            <a:off x="2453760" y="3182760"/>
            <a:ext cx="6040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++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2"/>
          <p:cNvSpPr/>
          <p:nvPr/>
        </p:nvSpPr>
        <p:spPr>
          <a:xfrm>
            <a:off x="7013520" y="1413000"/>
            <a:ext cx="582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 or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13"/>
          <p:cNvSpPr/>
          <p:nvPr/>
        </p:nvSpPr>
        <p:spPr>
          <a:xfrm rot="16200000">
            <a:off x="7056360" y="1333440"/>
            <a:ext cx="441360" cy="42552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4"/>
          <p:cNvSpPr/>
          <p:nvPr/>
        </p:nvSpPr>
        <p:spPr>
          <a:xfrm>
            <a:off x="250920" y="2333520"/>
            <a:ext cx="4216320" cy="5486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marL="152280" indent="-152280">
              <a:buClr>
                <a:srgbClr val="000000"/>
              </a:buClr>
              <a:buFont typeface="Arial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≧ 80 OR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≧ 30 AND %SS ≧ 50%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least one Ratio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52280" indent="-1522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52280" indent="-1522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) When SS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 at any Ratio, maximum  | -SS|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＜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ximum |+SS|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7"/>
          <p:cNvSpPr/>
          <p:nvPr/>
        </p:nvSpPr>
        <p:spPr>
          <a:xfrm>
            <a:off x="4284720" y="5013360"/>
            <a:ext cx="4589280" cy="853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 (i)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10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OR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5%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more than two Ratios including R1 or 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ii) SS at R4 ≦ SS at both R1 and 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When R4 does not meet (i), SS at  R3 is used  instead of R4. )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 AND %SS ≧10%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either R1 or R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23"/>
          <p:cNvSpPr/>
          <p:nvPr/>
        </p:nvSpPr>
        <p:spPr>
          <a:xfrm>
            <a:off x="2195280" y="199224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or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5"/>
          <p:cNvSpPr/>
          <p:nvPr/>
        </p:nvSpPr>
        <p:spPr>
          <a:xfrm>
            <a:off x="7553520" y="1317600"/>
            <a:ext cx="412200" cy="366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-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31"/>
          <p:cNvSpPr/>
          <p:nvPr/>
        </p:nvSpPr>
        <p:spPr>
          <a:xfrm>
            <a:off x="2187720" y="404640"/>
            <a:ext cx="411300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LISPO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32"/>
          <p:cNvSpPr/>
          <p:nvPr/>
        </p:nvSpPr>
        <p:spPr>
          <a:xfrm>
            <a:off x="2151000" y="404640"/>
            <a:ext cx="4029120" cy="543240"/>
          </a:xfrm>
          <a:prstGeom prst="downArrowCallout">
            <a:avLst>
              <a:gd name="adj1" fmla="val 74519"/>
              <a:gd name="adj2" fmla="val 62391"/>
              <a:gd name="adj3" fmla="val 30407"/>
              <a:gd name="adj4" fmla="val 4912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38"/>
          <p:cNvSpPr/>
          <p:nvPr/>
        </p:nvSpPr>
        <p:spPr>
          <a:xfrm>
            <a:off x="5575320" y="1992240"/>
            <a:ext cx="2538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9"/>
          <p:cNvSpPr/>
          <p:nvPr/>
        </p:nvSpPr>
        <p:spPr>
          <a:xfrm>
            <a:off x="755640" y="1052640"/>
            <a:ext cx="5931000" cy="853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) SS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＞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 at more than three Ratios AND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20 AND %SS ≧ 10%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more than two Ratio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)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80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OR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30 AND %SS ≧ 50%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least one Ratio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) SS ≦ 0 at more than three Ratios including R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) Any spot number ≦ 5 at all Ratio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) None of abov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0"/>
          <p:cNvSpPr/>
          <p:nvPr/>
        </p:nvSpPr>
        <p:spPr>
          <a:xfrm>
            <a:off x="6006960" y="4654440"/>
            <a:ext cx="5590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2"/>
          <p:cNvSpPr/>
          <p:nvPr/>
        </p:nvSpPr>
        <p:spPr>
          <a:xfrm>
            <a:off x="4546440" y="2343240"/>
            <a:ext cx="4327560" cy="2440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negative 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OR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ximum  | -SS|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＜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ximum |+SS|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”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7"/>
          <p:cNvSpPr/>
          <p:nvPr/>
        </p:nvSpPr>
        <p:spPr>
          <a:xfrm>
            <a:off x="3710160" y="386064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8"/>
          <p:cNvSpPr/>
          <p:nvPr/>
        </p:nvSpPr>
        <p:spPr>
          <a:xfrm>
            <a:off x="3204720" y="3811680"/>
            <a:ext cx="6040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++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50"/>
          <p:cNvSpPr/>
          <p:nvPr/>
        </p:nvSpPr>
        <p:spPr>
          <a:xfrm>
            <a:off x="5367960" y="596736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52"/>
          <p:cNvSpPr/>
          <p:nvPr/>
        </p:nvSpPr>
        <p:spPr>
          <a:xfrm>
            <a:off x="5294160" y="5918040"/>
            <a:ext cx="503280" cy="32400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3"/>
          <p:cNvSpPr/>
          <p:nvPr/>
        </p:nvSpPr>
        <p:spPr>
          <a:xfrm>
            <a:off x="6659640" y="5948280"/>
            <a:ext cx="3920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6"/>
          <p:cNvSpPr/>
          <p:nvPr/>
        </p:nvSpPr>
        <p:spPr>
          <a:xfrm>
            <a:off x="4284720" y="3605040"/>
            <a:ext cx="4589280" cy="853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marL="152280" indent="-152280">
              <a:buClr>
                <a:srgbClr val="000000"/>
              </a:buClr>
              <a:buFont typeface="Arial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＞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 at more than three Ratio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52280" indent="-1522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) SS of R4 is not greater than SS of both R1 and R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52280" indent="-1522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When SS of R4 is negative, SS of R3 is used instead of R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52280" indent="-1522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)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≧ 10 AND %SS ≧ 5%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more than two Ratio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52280" indent="-1522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) 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20 AND %SS ≧ 10%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t either R1 and R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utoShape 49"/>
          <p:cNvSpPr/>
          <p:nvPr/>
        </p:nvSpPr>
        <p:spPr>
          <a:xfrm>
            <a:off x="5913360" y="4637160"/>
            <a:ext cx="503280" cy="30456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AutoShape 52"/>
          <p:cNvSpPr/>
          <p:nvPr/>
        </p:nvSpPr>
        <p:spPr>
          <a:xfrm>
            <a:off x="6566040" y="5923080"/>
            <a:ext cx="502920" cy="32364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utoShape 13"/>
          <p:cNvSpPr/>
          <p:nvPr/>
        </p:nvSpPr>
        <p:spPr>
          <a:xfrm rot="5400000">
            <a:off x="3702240" y="3813120"/>
            <a:ext cx="452160" cy="36360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2"/>
          <p:cNvSpPr/>
          <p:nvPr/>
        </p:nvSpPr>
        <p:spPr>
          <a:xfrm>
            <a:off x="119160" y="115920"/>
            <a:ext cx="15080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a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1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6"/>
          <p:cNvSpPr/>
          <p:nvPr/>
        </p:nvSpPr>
        <p:spPr>
          <a:xfrm>
            <a:off x="5435640" y="1968480"/>
            <a:ext cx="533520" cy="30492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50"/>
          <p:cNvSpPr/>
          <p:nvPr/>
        </p:nvSpPr>
        <p:spPr>
          <a:xfrm>
            <a:off x="5365800" y="299736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52"/>
          <p:cNvSpPr/>
          <p:nvPr/>
        </p:nvSpPr>
        <p:spPr>
          <a:xfrm>
            <a:off x="5292720" y="2808360"/>
            <a:ext cx="536760" cy="620640"/>
          </a:xfrm>
          <a:prstGeom prst="downArrow">
            <a:avLst>
              <a:gd name="adj1" fmla="val 50000"/>
              <a:gd name="adj2" fmla="val 25026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50"/>
          <p:cNvSpPr/>
          <p:nvPr/>
        </p:nvSpPr>
        <p:spPr>
          <a:xfrm>
            <a:off x="1301040" y="297324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52"/>
          <p:cNvSpPr/>
          <p:nvPr/>
        </p:nvSpPr>
        <p:spPr>
          <a:xfrm>
            <a:off x="1227240" y="2924280"/>
            <a:ext cx="503280" cy="32364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53"/>
          <p:cNvSpPr/>
          <p:nvPr/>
        </p:nvSpPr>
        <p:spPr>
          <a:xfrm>
            <a:off x="2576520" y="2954160"/>
            <a:ext cx="4827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52"/>
          <p:cNvSpPr/>
          <p:nvPr/>
        </p:nvSpPr>
        <p:spPr>
          <a:xfrm>
            <a:off x="2498760" y="2928960"/>
            <a:ext cx="503280" cy="324000"/>
          </a:xfrm>
          <a:prstGeom prst="down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AutoShape 6"/>
          <p:cNvSpPr/>
          <p:nvPr/>
        </p:nvSpPr>
        <p:spPr>
          <a:xfrm>
            <a:off x="2195640" y="1968480"/>
            <a:ext cx="533160" cy="304920"/>
          </a:xfrm>
          <a:prstGeom prst="downArrow">
            <a:avLst>
              <a:gd name="adj1" fmla="val 71426"/>
              <a:gd name="adj2" fmla="val 3437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44" descr=""/>
          <p:cNvPicPr/>
          <p:nvPr/>
        </p:nvPicPr>
        <p:blipFill>
          <a:blip r:embed="rId1"/>
          <a:stretch/>
        </p:blipFill>
        <p:spPr>
          <a:xfrm>
            <a:off x="6848640" y="2637000"/>
            <a:ext cx="603000" cy="3412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45" descr=""/>
          <p:cNvPicPr/>
          <p:nvPr/>
        </p:nvPicPr>
        <p:blipFill>
          <a:blip r:embed="rId2"/>
          <a:stretch/>
        </p:blipFill>
        <p:spPr>
          <a:xfrm>
            <a:off x="6875640" y="3006720"/>
            <a:ext cx="523800" cy="49356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46" descr=""/>
          <p:cNvPicPr/>
          <p:nvPr/>
        </p:nvPicPr>
        <p:blipFill>
          <a:blip r:embed="rId3"/>
          <a:stretch/>
        </p:blipFill>
        <p:spPr>
          <a:xfrm>
            <a:off x="6568920" y="6237360"/>
            <a:ext cx="524160" cy="49356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49" descr=""/>
          <p:cNvPicPr/>
          <p:nvPr/>
        </p:nvPicPr>
        <p:blipFill>
          <a:blip r:embed="rId4"/>
          <a:stretch/>
        </p:blipFill>
        <p:spPr>
          <a:xfrm>
            <a:off x="5288040" y="6248520"/>
            <a:ext cx="579240" cy="493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9T00:33:46Z</dcterms:created>
  <dc:creator>免疫学</dc:creator>
  <dc:description/>
  <dc:language>en-US</dc:language>
  <cp:lastModifiedBy>Koji Kono</cp:lastModifiedBy>
  <cp:lastPrinted>2011-11-24T01:53:12Z</cp:lastPrinted>
  <dcterms:modified xsi:type="dcterms:W3CDTF">2011-12-02T04:27:01Z</dcterms:modified>
  <cp:revision>216</cp:revision>
  <dc:subject/>
  <dc:title>PowerPoint プレゼンテーション</dc:title>
</cp:coreProperties>
</file>